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fad.mfroot.org\RCHHome\users16\TRUSS2\2014-PRESENT\Gel%20images\OXPHOS%20u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fad.mfroot.org\RCHHome\users16\TRUSS2\2014-PRESENT\Gel%20images\pr.n%20c45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32</c:f>
              <c:strCache>
                <c:ptCount val="1"/>
                <c:pt idx="0">
                  <c:v>CI</c:v>
                </c:pt>
              </c:strCache>
            </c:strRef>
          </c:tx>
          <c:invertIfNegative val="0"/>
          <c:cat>
            <c:strRef>
              <c:f>Sheet1!$N$33:$N$38</c:f>
              <c:strCache>
                <c:ptCount val="6"/>
                <c:pt idx="0">
                  <c:v>0 h</c:v>
                </c:pt>
                <c:pt idx="1">
                  <c:v>2 h</c:v>
                </c:pt>
                <c:pt idx="2">
                  <c:v>8 h</c:v>
                </c:pt>
                <c:pt idx="3">
                  <c:v>24 h </c:v>
                </c:pt>
                <c:pt idx="4">
                  <c:v>48 h</c:v>
                </c:pt>
                <c:pt idx="5">
                  <c:v>72 h</c:v>
                </c:pt>
              </c:strCache>
            </c:strRef>
          </c:cat>
          <c:val>
            <c:numRef>
              <c:f>Sheet1!$O$33:$O$38</c:f>
              <c:numCache>
                <c:formatCode>General</c:formatCode>
                <c:ptCount val="6"/>
                <c:pt idx="0">
                  <c:v>100</c:v>
                </c:pt>
                <c:pt idx="1">
                  <c:v>108.42105263157895</c:v>
                </c:pt>
                <c:pt idx="2">
                  <c:v>108.42105263157895</c:v>
                </c:pt>
                <c:pt idx="3">
                  <c:v>108.42105263157895</c:v>
                </c:pt>
                <c:pt idx="4">
                  <c:v>113.68421052631578</c:v>
                </c:pt>
                <c:pt idx="5">
                  <c:v>122.105263157894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30-4229-8162-A1085B3F28F3}"/>
            </c:ext>
          </c:extLst>
        </c:ser>
        <c:ser>
          <c:idx val="1"/>
          <c:order val="1"/>
          <c:tx>
            <c:strRef>
              <c:f>Sheet1!$P$32</c:f>
              <c:strCache>
                <c:ptCount val="1"/>
                <c:pt idx="0">
                  <c:v>CII</c:v>
                </c:pt>
              </c:strCache>
            </c:strRef>
          </c:tx>
          <c:invertIfNegative val="0"/>
          <c:cat>
            <c:strRef>
              <c:f>Sheet1!$N$33:$N$38</c:f>
              <c:strCache>
                <c:ptCount val="6"/>
                <c:pt idx="0">
                  <c:v>0 h</c:v>
                </c:pt>
                <c:pt idx="1">
                  <c:v>2 h</c:v>
                </c:pt>
                <c:pt idx="2">
                  <c:v>8 h</c:v>
                </c:pt>
                <c:pt idx="3">
                  <c:v>24 h </c:v>
                </c:pt>
                <c:pt idx="4">
                  <c:v>48 h</c:v>
                </c:pt>
                <c:pt idx="5">
                  <c:v>72 h</c:v>
                </c:pt>
              </c:strCache>
            </c:strRef>
          </c:cat>
          <c:val>
            <c:numRef>
              <c:f>Sheet1!$P$33:$P$38</c:f>
              <c:numCache>
                <c:formatCode>General</c:formatCode>
                <c:ptCount val="6"/>
                <c:pt idx="0">
                  <c:v>100</c:v>
                </c:pt>
                <c:pt idx="1">
                  <c:v>121.8801874303965</c:v>
                </c:pt>
                <c:pt idx="2">
                  <c:v>131.26011220608939</c:v>
                </c:pt>
                <c:pt idx="3">
                  <c:v>145.9109915740371</c:v>
                </c:pt>
                <c:pt idx="4">
                  <c:v>135.00661889853123</c:v>
                </c:pt>
                <c:pt idx="5">
                  <c:v>165.010191002500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030-4229-8162-A1085B3F28F3}"/>
            </c:ext>
          </c:extLst>
        </c:ser>
        <c:ser>
          <c:idx val="2"/>
          <c:order val="2"/>
          <c:tx>
            <c:strRef>
              <c:f>Sheet1!$Q$32</c:f>
              <c:strCache>
                <c:ptCount val="1"/>
                <c:pt idx="0">
                  <c:v>CIII</c:v>
                </c:pt>
              </c:strCache>
            </c:strRef>
          </c:tx>
          <c:invertIfNegative val="0"/>
          <c:cat>
            <c:strRef>
              <c:f>Sheet1!$N$33:$N$38</c:f>
              <c:strCache>
                <c:ptCount val="6"/>
                <c:pt idx="0">
                  <c:v>0 h</c:v>
                </c:pt>
                <c:pt idx="1">
                  <c:v>2 h</c:v>
                </c:pt>
                <c:pt idx="2">
                  <c:v>8 h</c:v>
                </c:pt>
                <c:pt idx="3">
                  <c:v>24 h </c:v>
                </c:pt>
                <c:pt idx="4">
                  <c:v>48 h</c:v>
                </c:pt>
                <c:pt idx="5">
                  <c:v>72 h</c:v>
                </c:pt>
              </c:strCache>
            </c:strRef>
          </c:cat>
          <c:val>
            <c:numRef>
              <c:f>Sheet1!$Q$33:$Q$38</c:f>
              <c:numCache>
                <c:formatCode>General</c:formatCode>
                <c:ptCount val="6"/>
                <c:pt idx="0">
                  <c:v>100</c:v>
                </c:pt>
                <c:pt idx="1">
                  <c:v>98.702247933627248</c:v>
                </c:pt>
                <c:pt idx="2">
                  <c:v>117.71832015364639</c:v>
                </c:pt>
                <c:pt idx="3">
                  <c:v>115.83039803432162</c:v>
                </c:pt>
                <c:pt idx="4">
                  <c:v>106.88453972178809</c:v>
                </c:pt>
                <c:pt idx="5">
                  <c:v>137.3611078712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030-4229-8162-A1085B3F28F3}"/>
            </c:ext>
          </c:extLst>
        </c:ser>
        <c:ser>
          <c:idx val="3"/>
          <c:order val="3"/>
          <c:tx>
            <c:strRef>
              <c:f>Sheet1!$R$32</c:f>
              <c:strCache>
                <c:ptCount val="1"/>
                <c:pt idx="0">
                  <c:v>CIV</c:v>
                </c:pt>
              </c:strCache>
            </c:strRef>
          </c:tx>
          <c:invertIfNegative val="0"/>
          <c:cat>
            <c:strRef>
              <c:f>Sheet1!$N$33:$N$38</c:f>
              <c:strCache>
                <c:ptCount val="6"/>
                <c:pt idx="0">
                  <c:v>0 h</c:v>
                </c:pt>
                <c:pt idx="1">
                  <c:v>2 h</c:v>
                </c:pt>
                <c:pt idx="2">
                  <c:v>8 h</c:v>
                </c:pt>
                <c:pt idx="3">
                  <c:v>24 h </c:v>
                </c:pt>
                <c:pt idx="4">
                  <c:v>48 h</c:v>
                </c:pt>
                <c:pt idx="5">
                  <c:v>72 h</c:v>
                </c:pt>
              </c:strCache>
            </c:strRef>
          </c:cat>
          <c:val>
            <c:numRef>
              <c:f>Sheet1!$R$33:$R$38</c:f>
              <c:numCache>
                <c:formatCode>General</c:formatCode>
                <c:ptCount val="6"/>
                <c:pt idx="0">
                  <c:v>100</c:v>
                </c:pt>
                <c:pt idx="1">
                  <c:v>103.26086956521738</c:v>
                </c:pt>
                <c:pt idx="2">
                  <c:v>109.78260869565217</c:v>
                </c:pt>
                <c:pt idx="3">
                  <c:v>123.50543478260869</c:v>
                </c:pt>
                <c:pt idx="4">
                  <c:v>125.95108695652173</c:v>
                </c:pt>
                <c:pt idx="5">
                  <c:v>149.728260869565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030-4229-8162-A1085B3F28F3}"/>
            </c:ext>
          </c:extLst>
        </c:ser>
        <c:ser>
          <c:idx val="4"/>
          <c:order val="4"/>
          <c:tx>
            <c:strRef>
              <c:f>Sheet1!$S$32</c:f>
              <c:strCache>
                <c:ptCount val="1"/>
                <c:pt idx="0">
                  <c:v>CV</c:v>
                </c:pt>
              </c:strCache>
            </c:strRef>
          </c:tx>
          <c:invertIfNegative val="0"/>
          <c:cat>
            <c:strRef>
              <c:f>Sheet1!$N$33:$N$38</c:f>
              <c:strCache>
                <c:ptCount val="6"/>
                <c:pt idx="0">
                  <c:v>0 h</c:v>
                </c:pt>
                <c:pt idx="1">
                  <c:v>2 h</c:v>
                </c:pt>
                <c:pt idx="2">
                  <c:v>8 h</c:v>
                </c:pt>
                <c:pt idx="3">
                  <c:v>24 h </c:v>
                </c:pt>
                <c:pt idx="4">
                  <c:v>48 h</c:v>
                </c:pt>
                <c:pt idx="5">
                  <c:v>72 h</c:v>
                </c:pt>
              </c:strCache>
            </c:strRef>
          </c:cat>
          <c:val>
            <c:numRef>
              <c:f>Sheet1!$S$33:$S$38</c:f>
              <c:numCache>
                <c:formatCode>General</c:formatCode>
                <c:ptCount val="6"/>
                <c:pt idx="0">
                  <c:v>100</c:v>
                </c:pt>
                <c:pt idx="1">
                  <c:v>108.65289731922591</c:v>
                </c:pt>
                <c:pt idx="2">
                  <c:v>141.96453045337427</c:v>
                </c:pt>
                <c:pt idx="3">
                  <c:v>132.84085302340881</c:v>
                </c:pt>
                <c:pt idx="4">
                  <c:v>143.95318239131626</c:v>
                </c:pt>
                <c:pt idx="5">
                  <c:v>161.42755331396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030-4229-8162-A1085B3F28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9327360"/>
        <c:axId val="139328896"/>
      </c:barChart>
      <c:catAx>
        <c:axId val="1393273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39328896"/>
        <c:crosses val="autoZero"/>
        <c:auto val="1"/>
        <c:lblAlgn val="ctr"/>
        <c:lblOffset val="100"/>
        <c:noMultiLvlLbl val="0"/>
      </c:catAx>
      <c:valAx>
        <c:axId val="139328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/>
        </c:spPr>
        <c:crossAx val="139327360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9</c:f>
              <c:strCache>
                <c:ptCount val="1"/>
                <c:pt idx="0">
                  <c:v>p-AMPK-a</c:v>
                </c:pt>
              </c:strCache>
            </c:strRef>
          </c:tx>
          <c:invertIfNegative val="0"/>
          <c:cat>
            <c:numRef>
              <c:f>Sheet1!$B$30:$B$35</c:f>
              <c:numCache>
                <c:formatCode>General</c:formatCode>
                <c:ptCount val="6"/>
                <c:pt idx="0">
                  <c:v>0</c:v>
                </c:pt>
                <c:pt idx="1">
                  <c:v>2</c:v>
                </c:pt>
                <c:pt idx="2">
                  <c:v>8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</c:numCache>
            </c:numRef>
          </c:cat>
          <c:val>
            <c:numRef>
              <c:f>Sheet1!$C$30:$C$35</c:f>
              <c:numCache>
                <c:formatCode>General</c:formatCode>
                <c:ptCount val="6"/>
                <c:pt idx="0">
                  <c:v>100.00165968671413</c:v>
                </c:pt>
                <c:pt idx="1">
                  <c:v>101.03057266469382</c:v>
                </c:pt>
                <c:pt idx="2">
                  <c:v>150.34189839020237</c:v>
                </c:pt>
                <c:pt idx="3">
                  <c:v>136.93846098060683</c:v>
                </c:pt>
                <c:pt idx="4">
                  <c:v>193.35169962611428</c:v>
                </c:pt>
                <c:pt idx="5">
                  <c:v>212.24835996134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77-46C0-8195-F7E2257010B3}"/>
            </c:ext>
          </c:extLst>
        </c:ser>
        <c:ser>
          <c:idx val="1"/>
          <c:order val="1"/>
          <c:tx>
            <c:strRef>
              <c:f>Sheet1!$D$29</c:f>
              <c:strCache>
                <c:ptCount val="1"/>
                <c:pt idx="0">
                  <c:v>PGC-1a</c:v>
                </c:pt>
              </c:strCache>
            </c:strRef>
          </c:tx>
          <c:invertIfNegative val="0"/>
          <c:cat>
            <c:numRef>
              <c:f>Sheet1!$B$30:$B$35</c:f>
              <c:numCache>
                <c:formatCode>General</c:formatCode>
                <c:ptCount val="6"/>
                <c:pt idx="0">
                  <c:v>0</c:v>
                </c:pt>
                <c:pt idx="1">
                  <c:v>2</c:v>
                </c:pt>
                <c:pt idx="2">
                  <c:v>8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</c:numCache>
            </c:numRef>
          </c:cat>
          <c:val>
            <c:numRef>
              <c:f>Sheet1!$D$30:$D$35</c:f>
              <c:numCache>
                <c:formatCode>General</c:formatCode>
                <c:ptCount val="6"/>
                <c:pt idx="0">
                  <c:v>100.01759643821788</c:v>
                </c:pt>
                <c:pt idx="1">
                  <c:v>151.9397506139899</c:v>
                </c:pt>
                <c:pt idx="2">
                  <c:v>174.26762642919468</c:v>
                </c:pt>
                <c:pt idx="3">
                  <c:v>160.33375155674392</c:v>
                </c:pt>
                <c:pt idx="4">
                  <c:v>166.9217599961859</c:v>
                </c:pt>
                <c:pt idx="5">
                  <c:v>141.148927300369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77-46C0-8195-F7E2257010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0771712"/>
        <c:axId val="140773248"/>
      </c:barChart>
      <c:catAx>
        <c:axId val="140771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/>
        </c:spPr>
        <c:crossAx val="140773248"/>
        <c:crosses val="autoZero"/>
        <c:auto val="1"/>
        <c:lblAlgn val="ctr"/>
        <c:lblOffset val="100"/>
        <c:noMultiLvlLbl val="0"/>
      </c:catAx>
      <c:valAx>
        <c:axId val="140773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0771712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8076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444762"/>
              </p:ext>
            </p:extLst>
          </p:nvPr>
        </p:nvGraphicFramePr>
        <p:xfrm>
          <a:off x="1143000" y="4343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1219539"/>
              </p:ext>
            </p:extLst>
          </p:nvPr>
        </p:nvGraphicFramePr>
        <p:xfrm>
          <a:off x="1143000" y="8382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/>
          <p:cNvSpPr txBox="1"/>
          <p:nvPr/>
        </p:nvSpPr>
        <p:spPr>
          <a:xfrm rot="16200000">
            <a:off x="145822" y="1896189"/>
            <a:ext cx="1905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/tubulin, % of control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88442" y="5439489"/>
            <a:ext cx="19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/tubulin, % of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4BB52E-2A01-758D-0D6A-10729EB3E84C}"/>
              </a:ext>
            </a:extLst>
          </p:cNvPr>
          <p:cNvSpPr txBox="1"/>
          <p:nvPr/>
        </p:nvSpPr>
        <p:spPr>
          <a:xfrm>
            <a:off x="152401" y="7922566"/>
            <a:ext cx="649915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ntification of proteins presented on the Western blot in Fig. 7b.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6831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32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29:15Z</dcterms:modified>
</cp:coreProperties>
</file>